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7" d="100"/>
          <a:sy n="77" d="100"/>
        </p:scale>
        <p:origin x="313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55137;&#50672;\240703\PAF&#50836;&#51064;&#48324;&#44536;&#47548;&#44536;&#47532;&#44592;_SMK_Soseul_240624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55137;&#50672;\240703\PAF&#50836;&#51064;&#48324;&#44536;&#47548;&#44536;&#47532;&#44592;_SMK_Soseul_240624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55137;&#50672;\240703\PAF&#50836;&#51064;&#48324;&#44536;&#47548;&#44536;&#47532;&#44592;_SMK_Soseul_240624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55137;&#50672;\240703\PAF&#50836;&#51064;&#48324;&#44536;&#47548;&#44536;&#47532;&#44592;_SMK_Soseul_240624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55137;&#50672;\240703\PAF&#50836;&#51064;&#48324;&#44536;&#47548;&#44536;&#47532;&#44592;_SMK_Soseul_240624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24\PAF\&#55137;&#50672;\240703\PAF&#50836;&#51064;&#48324;&#44536;&#47548;&#44536;&#47532;&#44592;_SMK_Soseul_240624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9B55-4630-BDBD-0E459F9C5E91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9B55-4630-BDBD-0E459F9C5E91}"/>
              </c:ext>
            </c:extLst>
          </c:dPt>
          <c:dLbls>
            <c:dLbl>
              <c:idx val="0"/>
              <c:layout>
                <c:manualLayout>
                  <c:x val="5.4630542865811878E-2"/>
                  <c:y val="-0.26685603564662963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9B55-4630-BDBD-0E459F9C5E91}"/>
                </c:ext>
              </c:extLst>
            </c:dLbl>
            <c:dLbl>
              <c:idx val="1"/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FE9CDE63-E94A-464D-BFC0-F5BB1B4DABEC}" type="CATEGORYNAM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 </a:t>
                    </a:r>
                    <a:fld id="{28FCF578-7890-4DCD-84F5-5B7E3D09DAC3}" type="PERCENTAG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9B55-4630-BDBD-0E459F9C5E91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녀_2020_D!$A$1:$A$2</c:f>
              <c:strCache>
                <c:ptCount val="2"/>
                <c:pt idx="0">
                  <c:v>Others</c:v>
                </c:pt>
                <c:pt idx="1">
                  <c:v>Smoking</c:v>
                </c:pt>
              </c:strCache>
            </c:strRef>
          </c:cat>
          <c:val>
            <c:numRef>
              <c:f>남녀_2020_D!$B$1:$B$2</c:f>
              <c:numCache>
                <c:formatCode>General</c:formatCode>
                <c:ptCount val="2"/>
                <c:pt idx="0">
                  <c:v>79.3</c:v>
                </c:pt>
                <c:pt idx="1">
                  <c:v>20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B55-4630-BDBD-0E459F9C5E91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127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15CB-4F4B-B426-46A7D9E93630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15CB-4F4B-B426-46A7D9E93630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15CB-4F4B-B426-46A7D9E93630}"/>
              </c:ext>
            </c:extLst>
          </c:dPt>
          <c:dPt>
            <c:idx val="3"/>
            <c:bubble3D val="0"/>
            <c:spPr>
              <a:solidFill>
                <a:schemeClr val="dk1">
                  <a:tint val="9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15CB-4F4B-B426-46A7D9E93630}"/>
              </c:ext>
            </c:extLst>
          </c:dPt>
          <c:dPt>
            <c:idx val="4"/>
            <c:bubble3D val="0"/>
            <c:spPr>
              <a:solidFill>
                <a:schemeClr val="dk1">
                  <a:tint val="3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15CB-4F4B-B426-46A7D9E93630}"/>
              </c:ext>
            </c:extLst>
          </c:dPt>
          <c:dPt>
            <c:idx val="5"/>
            <c:bubble3D val="0"/>
            <c:spPr>
              <a:solidFill>
                <a:schemeClr val="dk1">
                  <a:tint val="6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15CB-4F4B-B426-46A7D9E93630}"/>
              </c:ext>
            </c:extLst>
          </c:dPt>
          <c:dPt>
            <c:idx val="6"/>
            <c:bubble3D val="0"/>
            <c:spPr>
              <a:solidFill>
                <a:schemeClr val="dk1">
                  <a:tint val="8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15CB-4F4B-B426-46A7D9E93630}"/>
              </c:ext>
            </c:extLst>
          </c:dPt>
          <c:dPt>
            <c:idx val="7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15CB-4F4B-B426-46A7D9E93630}"/>
              </c:ext>
            </c:extLst>
          </c:dPt>
          <c:dPt>
            <c:idx val="8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1-15CB-4F4B-B426-46A7D9E93630}"/>
              </c:ext>
            </c:extLst>
          </c:dPt>
          <c:dPt>
            <c:idx val="9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3-15CB-4F4B-B426-46A7D9E93630}"/>
              </c:ext>
            </c:extLst>
          </c:dPt>
          <c:dPt>
            <c:idx val="10"/>
            <c:bubble3D val="0"/>
            <c:spPr>
              <a:solidFill>
                <a:schemeClr val="dk1">
                  <a:tint val="9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5-15CB-4F4B-B426-46A7D9E93630}"/>
              </c:ext>
            </c:extLst>
          </c:dPt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90F94388-9288-4D39-9232-E81D835958E9}" type="PERCENTAG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15CB-4F4B-B426-46A7D9E93630}"/>
                </c:ext>
              </c:extLst>
            </c:dLbl>
            <c:dLbl>
              <c:idx val="1"/>
              <c:layout>
                <c:manualLayout>
                  <c:x val="0.2610699319822814"/>
                  <c:y val="4.2574898577316743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15CB-4F4B-B426-46A7D9E93630}"/>
                </c:ext>
              </c:extLst>
            </c:dLbl>
            <c:dLbl>
              <c:idx val="2"/>
              <c:layout>
                <c:manualLayout>
                  <c:x val="0"/>
                  <c:y val="-1.5574685984591484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15CB-4F4B-B426-46A7D9E93630}"/>
                </c:ext>
              </c:extLst>
            </c:dLbl>
            <c:dLbl>
              <c:idx val="3"/>
              <c:layout>
                <c:manualLayout>
                  <c:x val="7.8682278951758347E-3"/>
                  <c:y val="1.241153276898312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15CB-4F4B-B426-46A7D9E93630}"/>
                </c:ext>
              </c:extLst>
            </c:dLbl>
            <c:dLbl>
              <c:idx val="4"/>
              <c:layout>
                <c:manualLayout>
                  <c:x val="-2.2245558460724509E-2"/>
                  <c:y val="3.6157156553674984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15CB-4F4B-B426-46A7D9E93630}"/>
                </c:ext>
              </c:extLst>
            </c:dLbl>
            <c:dLbl>
              <c:idx val="5"/>
              <c:layout>
                <c:manualLayout>
                  <c:x val="-3.2728184935094241E-3"/>
                  <c:y val="-1.7469789191613964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969775716360623"/>
                      <c:h val="8.330891333170326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B-15CB-4F4B-B426-46A7D9E93630}"/>
                </c:ext>
              </c:extLst>
            </c:dLbl>
            <c:dLbl>
              <c:idx val="6"/>
              <c:layout>
                <c:manualLayout>
                  <c:x val="0.17073514488668395"/>
                  <c:y val="-4.790535491750394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33087457742912779"/>
                      <c:h val="9.1657443060955412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D-15CB-4F4B-B426-46A7D9E93630}"/>
                </c:ext>
              </c:extLst>
            </c:dLbl>
            <c:dLbl>
              <c:idx val="7"/>
              <c:layout>
                <c:manualLayout>
                  <c:x val="0.23857895656951625"/>
                  <c:y val="-4.24229423349822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9723167087069086"/>
                      <c:h val="0.1163831906623286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F-15CB-4F4B-B426-46A7D9E93630}"/>
                </c:ext>
              </c:extLst>
            </c:dLbl>
            <c:dLbl>
              <c:idx val="8"/>
              <c:layout>
                <c:manualLayout>
                  <c:x val="0.31084187663018448"/>
                  <c:y val="-2.2391613126880863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5415634406102832"/>
                      <c:h val="8.2312226595559465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11-15CB-4F4B-B426-46A7D9E93630}"/>
                </c:ext>
              </c:extLst>
            </c:dLbl>
            <c:dLbl>
              <c:idx val="9"/>
              <c:layout>
                <c:manualLayout>
                  <c:x val="0.38046560688171122"/>
                  <c:y val="2.5745128138029458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2912864314078071"/>
                      <c:h val="0.10690509862367714"/>
                    </c:manualLayout>
                  </c15:layout>
                </c:ext>
                <c:ext xmlns:c16="http://schemas.microsoft.com/office/drawing/2014/chart" uri="{C3380CC4-5D6E-409C-BE32-E72D297353CC}">
                  <c16:uniqueId val="{00000013-15CB-4F4B-B426-46A7D9E93630}"/>
                </c:ext>
              </c:extLst>
            </c:dLbl>
            <c:dLbl>
              <c:idx val="10"/>
              <c:layout>
                <c:manualLayout>
                  <c:x val="0.36983995833171124"/>
                  <c:y val="0.10957052616244169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5-15CB-4F4B-B426-46A7D9E93630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녀_2020_D!$A$5:$A$15</c:f>
              <c:strCache>
                <c:ptCount val="11"/>
                <c:pt idx="0">
                  <c:v>Lung</c:v>
                </c:pt>
                <c:pt idx="1">
                  <c:v>Liver</c:v>
                </c:pt>
                <c:pt idx="2">
                  <c:v>Stomach</c:v>
                </c:pt>
                <c:pt idx="3">
                  <c:v>Pancreas</c:v>
                </c:pt>
                <c:pt idx="4">
                  <c:v>Colorectal</c:v>
                </c:pt>
                <c:pt idx="5">
                  <c:v>Esophagus</c:v>
                </c:pt>
                <c:pt idx="6">
                  <c:v>Bladder</c:v>
                </c:pt>
                <c:pt idx="7">
                  <c:v>Oral cavity/Pharynx</c:v>
                </c:pt>
                <c:pt idx="8">
                  <c:v>Kidney</c:v>
                </c:pt>
                <c:pt idx="9">
                  <c:v>Larynx</c:v>
                </c:pt>
                <c:pt idx="10">
                  <c:v>Cervix uteri</c:v>
                </c:pt>
              </c:strCache>
            </c:strRef>
          </c:cat>
          <c:val>
            <c:numRef>
              <c:f>남녀_2020_D!$B$5:$B$15</c:f>
              <c:numCache>
                <c:formatCode>General</c:formatCode>
                <c:ptCount val="11"/>
                <c:pt idx="0">
                  <c:v>10497</c:v>
                </c:pt>
                <c:pt idx="1">
                  <c:v>1852</c:v>
                </c:pt>
                <c:pt idx="2">
                  <c:v>1139</c:v>
                </c:pt>
                <c:pt idx="3">
                  <c:v>1018</c:v>
                </c:pt>
                <c:pt idx="4">
                  <c:v>683</c:v>
                </c:pt>
                <c:pt idx="5">
                  <c:v>568</c:v>
                </c:pt>
                <c:pt idx="6">
                  <c:v>395</c:v>
                </c:pt>
                <c:pt idx="7">
                  <c:v>377</c:v>
                </c:pt>
                <c:pt idx="8">
                  <c:v>194</c:v>
                </c:pt>
                <c:pt idx="9">
                  <c:v>185</c:v>
                </c:pt>
                <c:pt idx="10">
                  <c:v>6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15CB-4F4B-B426-46A7D9E93630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20B6-4BF6-AFB9-5B1A697E4FE3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20B6-4BF6-AFB9-5B1A697E4FE3}"/>
              </c:ext>
            </c:extLst>
          </c:dPt>
          <c:dLbls>
            <c:dLbl>
              <c:idx val="0"/>
              <c:layout>
                <c:manualLayout>
                  <c:x val="5.4630542865811878E-2"/>
                  <c:y val="-0.26685603564662963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20B6-4BF6-AFB9-5B1A697E4FE3}"/>
                </c:ext>
              </c:extLst>
            </c:dLbl>
            <c:dLbl>
              <c:idx val="1"/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FE9CDE63-E94A-464D-BFC0-F5BB1B4DABEC}" type="CATEGORYNAM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 </a:t>
                    </a:r>
                    <a:fld id="{28FCF578-7890-4DCD-84F5-5B7E3D09DAC3}" type="PERCENTAG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20B6-4BF6-AFB9-5B1A697E4FE3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자_2020_D!$A$1:$A$2</c:f>
              <c:strCache>
                <c:ptCount val="2"/>
                <c:pt idx="0">
                  <c:v>Others</c:v>
                </c:pt>
                <c:pt idx="1">
                  <c:v>Smoking</c:v>
                </c:pt>
              </c:strCache>
            </c:strRef>
          </c:cat>
          <c:val>
            <c:numRef>
              <c:f>남자_2020_D!$B$1:$B$2</c:f>
              <c:numCache>
                <c:formatCode>General</c:formatCode>
                <c:ptCount val="2"/>
                <c:pt idx="0">
                  <c:v>69.599999999999994</c:v>
                </c:pt>
                <c:pt idx="1">
                  <c:v>30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0B6-4BF6-AFB9-5B1A697E4FE3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146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C045-460D-9E41-2D8FB2CC9A12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C045-460D-9E41-2D8FB2CC9A12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C045-460D-9E41-2D8FB2CC9A12}"/>
              </c:ext>
            </c:extLst>
          </c:dPt>
          <c:dPt>
            <c:idx val="3"/>
            <c:bubble3D val="0"/>
            <c:spPr>
              <a:solidFill>
                <a:schemeClr val="dk1">
                  <a:tint val="9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C045-460D-9E41-2D8FB2CC9A12}"/>
              </c:ext>
            </c:extLst>
          </c:dPt>
          <c:dPt>
            <c:idx val="4"/>
            <c:bubble3D val="0"/>
            <c:spPr>
              <a:solidFill>
                <a:schemeClr val="dk1">
                  <a:tint val="3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C045-460D-9E41-2D8FB2CC9A12}"/>
              </c:ext>
            </c:extLst>
          </c:dPt>
          <c:dPt>
            <c:idx val="5"/>
            <c:bubble3D val="0"/>
            <c:spPr>
              <a:solidFill>
                <a:schemeClr val="dk1">
                  <a:tint val="6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C045-460D-9E41-2D8FB2CC9A12}"/>
              </c:ext>
            </c:extLst>
          </c:dPt>
          <c:dPt>
            <c:idx val="6"/>
            <c:bubble3D val="0"/>
            <c:spPr>
              <a:solidFill>
                <a:schemeClr val="dk1">
                  <a:tint val="8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C045-460D-9E41-2D8FB2CC9A12}"/>
              </c:ext>
            </c:extLst>
          </c:dPt>
          <c:dPt>
            <c:idx val="7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C045-460D-9E41-2D8FB2CC9A12}"/>
              </c:ext>
            </c:extLst>
          </c:dPt>
          <c:dPt>
            <c:idx val="8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1-C045-460D-9E41-2D8FB2CC9A12}"/>
              </c:ext>
            </c:extLst>
          </c:dPt>
          <c:dPt>
            <c:idx val="9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3-C045-460D-9E41-2D8FB2CC9A12}"/>
              </c:ext>
            </c:extLst>
          </c:dPt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4FC9A4F7-34E4-49DA-A358-CFC436E1648B}" type="PERCENTAG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C045-460D-9E41-2D8FB2CC9A12}"/>
                </c:ext>
              </c:extLst>
            </c:dLbl>
            <c:dLbl>
              <c:idx val="1"/>
              <c:layout>
                <c:manualLayout>
                  <c:x val="1.1095227530896543E-2"/>
                  <c:y val="-9.1684738989581251E-4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C045-460D-9E41-2D8FB2CC9A12}"/>
                </c:ext>
              </c:extLst>
            </c:dLbl>
            <c:dLbl>
              <c:idx val="2"/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6="http://schemas.microsoft.com/office/drawing/2014/chart" uri="{C3380CC4-5D6E-409C-BE32-E72D297353CC}">
                  <c16:uniqueId val="{00000005-C045-460D-9E41-2D8FB2CC9A12}"/>
                </c:ext>
              </c:extLst>
            </c:dLbl>
            <c:dLbl>
              <c:idx val="3"/>
              <c:layout>
                <c:manualLayout>
                  <c:x val="7.8682278951758347E-3"/>
                  <c:y val="1.241153276898312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C045-460D-9E41-2D8FB2CC9A12}"/>
                </c:ext>
              </c:extLst>
            </c:dLbl>
            <c:dLbl>
              <c:idx val="4"/>
              <c:layout>
                <c:manualLayout>
                  <c:x val="-2.2245450587018017E-2"/>
                  <c:y val="1.5776178953137997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C045-460D-9E41-2D8FB2CC9A12}"/>
                </c:ext>
              </c:extLst>
            </c:dLbl>
            <c:dLbl>
              <c:idx val="5"/>
              <c:layout>
                <c:manualLayout>
                  <c:x val="-2.4436720837543544E-2"/>
                  <c:y val="5.692403748266954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7164736284097512"/>
                      <c:h val="0.10535756572391269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B-C045-460D-9E41-2D8FB2CC9A12}"/>
                </c:ext>
              </c:extLst>
            </c:dLbl>
            <c:dLbl>
              <c:idx val="6"/>
              <c:layout>
                <c:manualLayout>
                  <c:x val="3.3500039737759633E-5"/>
                  <c:y val="-4.4074043805122906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669267717896144"/>
                      <c:h val="9.699437708723814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D-C045-460D-9E41-2D8FB2CC9A12}"/>
                </c:ext>
              </c:extLst>
            </c:dLbl>
            <c:dLbl>
              <c:idx val="7"/>
              <c:layout>
                <c:manualLayout>
                  <c:x val="0.17355077854723228"/>
                  <c:y val="-9.0454798295278964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9280541890491624"/>
                      <c:h val="9.5949933368101828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F-C045-460D-9E41-2D8FB2CC9A12}"/>
                </c:ext>
              </c:extLst>
            </c:dLbl>
            <c:dLbl>
              <c:idx val="8"/>
              <c:layout>
                <c:manualLayout>
                  <c:x val="0.23891795379225261"/>
                  <c:y val="-4.894441045527052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C045-460D-9E41-2D8FB2CC9A12}"/>
                </c:ext>
              </c:extLst>
            </c:dLbl>
            <c:dLbl>
              <c:idx val="9"/>
              <c:layout>
                <c:manualLayout>
                  <c:x val="0.31247743957810259"/>
                  <c:y val="4.71944116705474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2896821557654931"/>
                      <c:h val="0.10278117862418151"/>
                    </c:manualLayout>
                  </c15:layout>
                </c:ext>
                <c:ext xmlns:c16="http://schemas.microsoft.com/office/drawing/2014/chart" uri="{C3380CC4-5D6E-409C-BE32-E72D297353CC}">
                  <c16:uniqueId val="{00000013-C045-460D-9E41-2D8FB2CC9A12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자_2020_D!$A$5:$A$14</c:f>
              <c:strCache>
                <c:ptCount val="10"/>
                <c:pt idx="0">
                  <c:v>Lung</c:v>
                </c:pt>
                <c:pt idx="1">
                  <c:v>Liver</c:v>
                </c:pt>
                <c:pt idx="2">
                  <c:v>Stomach</c:v>
                </c:pt>
                <c:pt idx="3">
                  <c:v>Pancreas</c:v>
                </c:pt>
                <c:pt idx="4">
                  <c:v>Colorectal</c:v>
                </c:pt>
                <c:pt idx="5">
                  <c:v>Esophagus</c:v>
                </c:pt>
                <c:pt idx="6">
                  <c:v>Bladder</c:v>
                </c:pt>
                <c:pt idx="7">
                  <c:v>Oral cavity/Pharynx</c:v>
                </c:pt>
                <c:pt idx="8">
                  <c:v>Larynx</c:v>
                </c:pt>
                <c:pt idx="9">
                  <c:v>Kidney</c:v>
                </c:pt>
              </c:strCache>
            </c:strRef>
          </c:cat>
          <c:val>
            <c:numRef>
              <c:f>남자_2020_D!$B$5:$B$14</c:f>
              <c:numCache>
                <c:formatCode>General</c:formatCode>
                <c:ptCount val="10"/>
                <c:pt idx="0">
                  <c:v>9701</c:v>
                </c:pt>
                <c:pt idx="1">
                  <c:v>1719</c:v>
                </c:pt>
                <c:pt idx="2">
                  <c:v>1049</c:v>
                </c:pt>
                <c:pt idx="3">
                  <c:v>787</c:v>
                </c:pt>
                <c:pt idx="4">
                  <c:v>586</c:v>
                </c:pt>
                <c:pt idx="5">
                  <c:v>493</c:v>
                </c:pt>
                <c:pt idx="6">
                  <c:v>378</c:v>
                </c:pt>
                <c:pt idx="7">
                  <c:v>354</c:v>
                </c:pt>
                <c:pt idx="8">
                  <c:v>178</c:v>
                </c:pt>
                <c:pt idx="9">
                  <c:v>1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C045-460D-9E41-2D8FB2CC9A12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F89C-422E-98EE-DC85505C5003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F89C-422E-98EE-DC85505C5003}"/>
              </c:ext>
            </c:extLst>
          </c:dPt>
          <c:dLbls>
            <c:dLbl>
              <c:idx val="0"/>
              <c:layout>
                <c:manualLayout>
                  <c:x val="5.4630542865811878E-2"/>
                  <c:y val="-0.26685603564662963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F89C-422E-98EE-DC85505C5003}"/>
                </c:ext>
              </c:extLst>
            </c:dLbl>
            <c:dLbl>
              <c:idx val="1"/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FE9CDE63-E94A-464D-BFC0-F5BB1B4DABEC}" type="CATEGORYNAM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 </a:t>
                    </a:r>
                    <a:fld id="{28FCF578-7890-4DCD-84F5-5B7E3D09DAC3}" type="PERCENTAG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F89C-422E-98EE-DC85505C5003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여자_2020_D!$A$1:$A$2</c:f>
              <c:strCache>
                <c:ptCount val="2"/>
                <c:pt idx="0">
                  <c:v>Others</c:v>
                </c:pt>
                <c:pt idx="1">
                  <c:v>Smoking</c:v>
                </c:pt>
              </c:strCache>
            </c:strRef>
          </c:cat>
          <c:val>
            <c:numRef>
              <c:f>여자_2020_D!$B$1:$B$2</c:f>
              <c:numCache>
                <c:formatCode>General</c:formatCode>
                <c:ptCount val="2"/>
                <c:pt idx="0">
                  <c:v>95</c:v>
                </c:pt>
                <c:pt idx="1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89C-422E-98EE-DC85505C5003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98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628289080842053"/>
          <c:y val="0.12864553077969818"/>
          <c:w val="0.74743455196979569"/>
          <c:h val="0.77798672846761407"/>
        </c:manualLayout>
      </c:layout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594A-4635-A905-402BA4487894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594A-4635-A905-402BA4487894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594A-4635-A905-402BA4487894}"/>
              </c:ext>
            </c:extLst>
          </c:dPt>
          <c:dPt>
            <c:idx val="3"/>
            <c:bubble3D val="0"/>
            <c:spPr>
              <a:solidFill>
                <a:schemeClr val="dk1">
                  <a:tint val="9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594A-4635-A905-402BA4487894}"/>
              </c:ext>
            </c:extLst>
          </c:dPt>
          <c:dPt>
            <c:idx val="4"/>
            <c:bubble3D val="0"/>
            <c:spPr>
              <a:solidFill>
                <a:schemeClr val="dk1">
                  <a:tint val="3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594A-4635-A905-402BA4487894}"/>
              </c:ext>
            </c:extLst>
          </c:dPt>
          <c:dPt>
            <c:idx val="5"/>
            <c:bubble3D val="0"/>
            <c:spPr>
              <a:solidFill>
                <a:schemeClr val="dk1">
                  <a:tint val="6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594A-4635-A905-402BA4487894}"/>
              </c:ext>
            </c:extLst>
          </c:dPt>
          <c:dPt>
            <c:idx val="6"/>
            <c:bubble3D val="0"/>
            <c:spPr>
              <a:solidFill>
                <a:schemeClr val="dk1">
                  <a:tint val="8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594A-4635-A905-402BA4487894}"/>
              </c:ext>
            </c:extLst>
          </c:dPt>
          <c:dPt>
            <c:idx val="7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594A-4635-A905-402BA4487894}"/>
              </c:ext>
            </c:extLst>
          </c:dPt>
          <c:dPt>
            <c:idx val="8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1-594A-4635-A905-402BA4487894}"/>
              </c:ext>
            </c:extLst>
          </c:dPt>
          <c:dPt>
            <c:idx val="9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3-594A-4635-A905-402BA4487894}"/>
              </c:ext>
            </c:extLst>
          </c:dPt>
          <c:dPt>
            <c:idx val="10"/>
            <c:bubble3D val="0"/>
            <c:spPr>
              <a:solidFill>
                <a:schemeClr val="dk1">
                  <a:tint val="9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5-594A-4635-A905-402BA4487894}"/>
              </c:ext>
            </c:extLst>
          </c:dPt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72DE87BD-D998-41D5-A1DB-FCEAE9B5F849}" type="PERCENTAG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594A-4635-A905-402BA4487894}"/>
                </c:ext>
              </c:extLst>
            </c:dLbl>
            <c:dLbl>
              <c:idx val="1"/>
              <c:layout>
                <c:manualLayout>
                  <c:x val="0.2610699319822814"/>
                  <c:y val="4.2574898577316743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594A-4635-A905-402BA4487894}"/>
                </c:ext>
              </c:extLst>
            </c:dLbl>
            <c:dLbl>
              <c:idx val="2"/>
              <c:layout>
                <c:manualLayout>
                  <c:x val="0"/>
                  <c:y val="-1.5574685984591484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594A-4635-A905-402BA4487894}"/>
                </c:ext>
              </c:extLst>
            </c:dLbl>
            <c:dLbl>
              <c:idx val="3"/>
              <c:layout>
                <c:manualLayout>
                  <c:x val="7.8682278951758347E-3"/>
                  <c:y val="1.241153276898312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594A-4635-A905-402BA4487894}"/>
                </c:ext>
              </c:extLst>
            </c:dLbl>
            <c:dLbl>
              <c:idx val="4"/>
              <c:layout>
                <c:manualLayout>
                  <c:x val="-2.2245450587018017E-2"/>
                  <c:y val="1.5776178953137997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594A-4635-A905-402BA4487894}"/>
                </c:ext>
              </c:extLst>
            </c:dLbl>
            <c:dLbl>
              <c:idx val="5"/>
              <c:layout>
                <c:manualLayout>
                  <c:x val="-3.5072711432334001E-2"/>
                  <c:y val="2.971116622206252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9299673392569244"/>
                      <c:h val="8.3308934013918493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B-594A-4635-A905-402BA4487894}"/>
                </c:ext>
              </c:extLst>
            </c:dLbl>
            <c:dLbl>
              <c:idx val="6"/>
              <c:layout>
                <c:manualLayout>
                  <c:x val="-7.5138167159105998E-2"/>
                  <c:y val="3.1118511974932823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594A-4635-A905-402BA4487894}"/>
                </c:ext>
              </c:extLst>
            </c:dLbl>
            <c:dLbl>
              <c:idx val="7"/>
              <c:layout>
                <c:manualLayout>
                  <c:x val="8.6139186045418967E-2"/>
                  <c:y val="-1.4972898269244384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8881030592095108"/>
                      <c:h val="8.9409734730599308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F-594A-4635-A905-402BA4487894}"/>
                </c:ext>
              </c:extLst>
            </c:dLbl>
            <c:dLbl>
              <c:idx val="8"/>
              <c:layout>
                <c:manualLayout>
                  <c:x val="0.17924640702445871"/>
                  <c:y val="-6.5148570642626497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5415622386502909"/>
                      <c:h val="9.6771424457666122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11-594A-4635-A905-402BA4487894}"/>
                </c:ext>
              </c:extLst>
            </c:dLbl>
            <c:dLbl>
              <c:idx val="9"/>
              <c:layout>
                <c:manualLayout>
                  <c:x val="0.27018139935108076"/>
                  <c:y val="0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5438990006411535"/>
                      <c:h val="0.11461193351040168"/>
                    </c:manualLayout>
                  </c15:layout>
                </c:ext>
                <c:ext xmlns:c16="http://schemas.microsoft.com/office/drawing/2014/chart" uri="{C3380CC4-5D6E-409C-BE32-E72D297353CC}">
                  <c16:uniqueId val="{00000013-594A-4635-A905-402BA4487894}"/>
                </c:ext>
              </c:extLst>
            </c:dLbl>
            <c:dLbl>
              <c:idx val="10"/>
              <c:layout>
                <c:manualLayout>
                  <c:x val="0.35298202115363703"/>
                  <c:y val="4.4847045964357513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5-594A-4635-A905-402BA4487894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여자_2020_D!$A$5:$A$15</c:f>
              <c:strCache>
                <c:ptCount val="11"/>
                <c:pt idx="0">
                  <c:v>Lung</c:v>
                </c:pt>
                <c:pt idx="1">
                  <c:v>Pancreas</c:v>
                </c:pt>
                <c:pt idx="2">
                  <c:v>Liver</c:v>
                </c:pt>
                <c:pt idx="3">
                  <c:v>Colorectal</c:v>
                </c:pt>
                <c:pt idx="4">
                  <c:v>Stomach</c:v>
                </c:pt>
                <c:pt idx="5">
                  <c:v>Esophagus</c:v>
                </c:pt>
                <c:pt idx="6">
                  <c:v>Cervix uteri</c:v>
                </c:pt>
                <c:pt idx="7">
                  <c:v>Oral cavity/Pharynx</c:v>
                </c:pt>
                <c:pt idx="8">
                  <c:v>Kidney</c:v>
                </c:pt>
                <c:pt idx="9">
                  <c:v>Bladder</c:v>
                </c:pt>
                <c:pt idx="10">
                  <c:v>Larynx</c:v>
                </c:pt>
              </c:strCache>
            </c:strRef>
          </c:cat>
          <c:val>
            <c:numRef>
              <c:f>여자_2020_D!$B$5:$B$15</c:f>
              <c:numCache>
                <c:formatCode>General</c:formatCode>
                <c:ptCount val="11"/>
                <c:pt idx="0">
                  <c:v>795</c:v>
                </c:pt>
                <c:pt idx="1">
                  <c:v>232</c:v>
                </c:pt>
                <c:pt idx="2">
                  <c:v>133</c:v>
                </c:pt>
                <c:pt idx="3">
                  <c:v>97</c:v>
                </c:pt>
                <c:pt idx="4">
                  <c:v>89</c:v>
                </c:pt>
                <c:pt idx="5">
                  <c:v>75</c:v>
                </c:pt>
                <c:pt idx="6">
                  <c:v>60</c:v>
                </c:pt>
                <c:pt idx="7">
                  <c:v>23</c:v>
                </c:pt>
                <c:pt idx="8">
                  <c:v>19</c:v>
                </c:pt>
                <c:pt idx="9">
                  <c:v>17</c:v>
                </c:pt>
                <c:pt idx="10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594A-4635-A905-402BA4487894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5397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0712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97467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5050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1590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4482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5682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7142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9130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7685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22209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4086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>
            <a:extLst>
              <a:ext uri="{FF2B5EF4-FFF2-40B4-BE49-F238E27FC236}">
                <a16:creationId xmlns:a16="http://schemas.microsoft.com/office/drawing/2014/main" id="{17C0745B-B0C9-489F-A3E6-0D2D71038754}"/>
              </a:ext>
            </a:extLst>
          </p:cNvPr>
          <p:cNvGrpSpPr/>
          <p:nvPr/>
        </p:nvGrpSpPr>
        <p:grpSpPr>
          <a:xfrm>
            <a:off x="508755" y="354849"/>
            <a:ext cx="5816199" cy="9350190"/>
            <a:chOff x="508755" y="620837"/>
            <a:chExt cx="5816199" cy="9350190"/>
          </a:xfrm>
        </p:grpSpPr>
        <p:sp>
          <p:nvSpPr>
            <p:cNvPr id="53" name="직사각형 52">
              <a:extLst>
                <a:ext uri="{FF2B5EF4-FFF2-40B4-BE49-F238E27FC236}">
                  <a16:creationId xmlns:a16="http://schemas.microsoft.com/office/drawing/2014/main" id="{E9FFEC05-C143-45B5-A6AA-E9F7914DFFBF}"/>
                </a:ext>
              </a:extLst>
            </p:cNvPr>
            <p:cNvSpPr/>
            <p:nvPr/>
          </p:nvSpPr>
          <p:spPr>
            <a:xfrm>
              <a:off x="601654" y="9417029"/>
              <a:ext cx="5630400" cy="553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Material 8. The population attributable fraction (%) of cancer deaths attributed to tobacco smoking and proportion of specific cancers among all-cancer deaths caused by tobacco smoking in Korea, 2020.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1" name="그룹 10">
              <a:extLst>
                <a:ext uri="{FF2B5EF4-FFF2-40B4-BE49-F238E27FC236}">
                  <a16:creationId xmlns:a16="http://schemas.microsoft.com/office/drawing/2014/main" id="{5EC55605-0FBE-42E6-A75C-9ECD771B16F0}"/>
                </a:ext>
              </a:extLst>
            </p:cNvPr>
            <p:cNvGrpSpPr/>
            <p:nvPr/>
          </p:nvGrpSpPr>
          <p:grpSpPr>
            <a:xfrm>
              <a:off x="508755" y="620837"/>
              <a:ext cx="5816199" cy="8856138"/>
              <a:chOff x="515254" y="620837"/>
              <a:chExt cx="5816199" cy="8856138"/>
            </a:xfrm>
          </p:grpSpPr>
          <p:grpSp>
            <p:nvGrpSpPr>
              <p:cNvPr id="24" name="그룹 23">
                <a:extLst>
                  <a:ext uri="{FF2B5EF4-FFF2-40B4-BE49-F238E27FC236}">
                    <a16:creationId xmlns:a16="http://schemas.microsoft.com/office/drawing/2014/main" id="{BEEBCE95-4882-4A26-9ECC-55649CCCF8B3}"/>
                  </a:ext>
                </a:extLst>
              </p:cNvPr>
              <p:cNvGrpSpPr/>
              <p:nvPr/>
            </p:nvGrpSpPr>
            <p:grpSpPr>
              <a:xfrm>
                <a:off x="515254" y="620837"/>
                <a:ext cx="5816199" cy="8856138"/>
                <a:chOff x="515254" y="620837"/>
                <a:chExt cx="5816199" cy="8856138"/>
              </a:xfrm>
            </p:grpSpPr>
            <p:grpSp>
              <p:nvGrpSpPr>
                <p:cNvPr id="2" name="그룹 1">
                  <a:extLst>
                    <a:ext uri="{FF2B5EF4-FFF2-40B4-BE49-F238E27FC236}">
                      <a16:creationId xmlns:a16="http://schemas.microsoft.com/office/drawing/2014/main" id="{4FC5D5FE-1F3D-4374-A3E1-42304720A1B0}"/>
                    </a:ext>
                  </a:extLst>
                </p:cNvPr>
                <p:cNvGrpSpPr/>
                <p:nvPr/>
              </p:nvGrpSpPr>
              <p:grpSpPr>
                <a:xfrm>
                  <a:off x="515254" y="620837"/>
                  <a:ext cx="5781925" cy="3022219"/>
                  <a:chOff x="515254" y="620837"/>
                  <a:chExt cx="5781925" cy="3022219"/>
                </a:xfrm>
              </p:grpSpPr>
              <p:grpSp>
                <p:nvGrpSpPr>
                  <p:cNvPr id="29" name="그룹 28">
                    <a:extLst>
                      <a:ext uri="{FF2B5EF4-FFF2-40B4-BE49-F238E27FC236}">
                        <a16:creationId xmlns:a16="http://schemas.microsoft.com/office/drawing/2014/main" id="{CCB6F206-44D6-4C48-8602-9CF796F6F7C2}"/>
                      </a:ext>
                    </a:extLst>
                  </p:cNvPr>
                  <p:cNvGrpSpPr/>
                  <p:nvPr/>
                </p:nvGrpSpPr>
                <p:grpSpPr>
                  <a:xfrm>
                    <a:off x="623086" y="677661"/>
                    <a:ext cx="5674093" cy="2965395"/>
                    <a:chOff x="0" y="0"/>
                    <a:chExt cx="6113798" cy="3579573"/>
                  </a:xfrm>
                </p:grpSpPr>
                <p:grpSp>
                  <p:nvGrpSpPr>
                    <p:cNvPr id="30" name="그룹 29">
                      <a:extLst>
                        <a:ext uri="{FF2B5EF4-FFF2-40B4-BE49-F238E27FC236}">
                          <a16:creationId xmlns:a16="http://schemas.microsoft.com/office/drawing/2014/main" id="{5082947D-3572-41F9-9422-BD261F2771C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0"/>
                      <a:ext cx="6113798" cy="3579573"/>
                      <a:chOff x="0" y="0"/>
                      <a:chExt cx="11105321" cy="4138820"/>
                    </a:xfrm>
                  </p:grpSpPr>
                  <p:graphicFrame>
                    <p:nvGraphicFramePr>
                      <p:cNvPr id="32" name="차트 31">
                        <a:extLst>
                          <a:ext uri="{FF2B5EF4-FFF2-40B4-BE49-F238E27FC236}">
                            <a16:creationId xmlns:a16="http://schemas.microsoft.com/office/drawing/2014/main" id="{88F98063-72BF-4C82-AE61-7ED7AAD78981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0" y="652478"/>
                      <a:ext cx="4681538" cy="2833864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2"/>
                      </a:graphicData>
                    </a:graphic>
                  </p:graphicFrame>
                  <p:graphicFrame>
                    <p:nvGraphicFramePr>
                      <p:cNvPr id="33" name="차트 32">
                        <a:extLst>
                          <a:ext uri="{FF2B5EF4-FFF2-40B4-BE49-F238E27FC236}">
                            <a16:creationId xmlns:a16="http://schemas.microsoft.com/office/drawing/2014/main" id="{92AABB33-0FDA-4BA3-A0DB-EAC6EE86FDC1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5273414" y="0"/>
                      <a:ext cx="5831907" cy="4138820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3"/>
                      </a:graphicData>
                    </a:graphic>
                  </p:graphicFrame>
                </p:grpSp>
                <p:cxnSp>
                  <p:nvCxnSpPr>
                    <p:cNvPr id="31" name="직선 연결선 30">
                      <a:extLst>
                        <a:ext uri="{FF2B5EF4-FFF2-40B4-BE49-F238E27FC236}">
                          <a16:creationId xmlns:a16="http://schemas.microsoft.com/office/drawing/2014/main" id="{C221E091-C21B-4E65-817C-5F0DF13E215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03279" y="2395820"/>
                      <a:ext cx="2092769" cy="721004"/>
                    </a:xfrm>
                    <a:prstGeom prst="line">
                      <a:avLst/>
                    </a:prstGeom>
                    <a:ln>
                      <a:solidFill>
                        <a:schemeClr val="accent3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46" name="TextBox 45">
                    <a:extLst>
                      <a:ext uri="{FF2B5EF4-FFF2-40B4-BE49-F238E27FC236}">
                        <a16:creationId xmlns:a16="http://schemas.microsoft.com/office/drawing/2014/main" id="{ED0E3951-E7A8-4D37-953A-49C87951C1DC}"/>
                      </a:ext>
                    </a:extLst>
                  </p:cNvPr>
                  <p:cNvSpPr txBox="1"/>
                  <p:nvPr/>
                </p:nvSpPr>
                <p:spPr>
                  <a:xfrm>
                    <a:off x="515254" y="620837"/>
                    <a:ext cx="158248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otal cancer deaths, 2020</a:t>
                    </a:r>
                    <a:endParaRPr lang="ko-KR" alt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3" name="그룹 2">
                  <a:extLst>
                    <a:ext uri="{FF2B5EF4-FFF2-40B4-BE49-F238E27FC236}">
                      <a16:creationId xmlns:a16="http://schemas.microsoft.com/office/drawing/2014/main" id="{BD782734-C29F-4802-9090-F82DD35DC37D}"/>
                    </a:ext>
                  </a:extLst>
                </p:cNvPr>
                <p:cNvGrpSpPr/>
                <p:nvPr/>
              </p:nvGrpSpPr>
              <p:grpSpPr>
                <a:xfrm>
                  <a:off x="515254" y="3579421"/>
                  <a:ext cx="5815786" cy="2980596"/>
                  <a:chOff x="515254" y="3579421"/>
                  <a:chExt cx="5815786" cy="2980596"/>
                </a:xfrm>
              </p:grpSpPr>
              <p:sp>
                <p:nvSpPr>
                  <p:cNvPr id="47" name="TextBox 46">
                    <a:extLst>
                      <a:ext uri="{FF2B5EF4-FFF2-40B4-BE49-F238E27FC236}">
                        <a16:creationId xmlns:a16="http://schemas.microsoft.com/office/drawing/2014/main" id="{258A911A-63B4-40A6-978C-8464EFBD17F1}"/>
                      </a:ext>
                    </a:extLst>
                  </p:cNvPr>
                  <p:cNvSpPr txBox="1"/>
                  <p:nvPr/>
                </p:nvSpPr>
                <p:spPr>
                  <a:xfrm>
                    <a:off x="515254" y="3579421"/>
                    <a:ext cx="156966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ale cancer deaths, 2020</a:t>
                    </a:r>
                    <a:endParaRPr lang="ko-KR" alt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34" name="그룹 33">
                    <a:extLst>
                      <a:ext uri="{FF2B5EF4-FFF2-40B4-BE49-F238E27FC236}">
                        <a16:creationId xmlns:a16="http://schemas.microsoft.com/office/drawing/2014/main" id="{DAEE77BA-3E5B-49B5-B7D5-9A1CD699A35A}"/>
                      </a:ext>
                    </a:extLst>
                  </p:cNvPr>
                  <p:cNvGrpSpPr/>
                  <p:nvPr/>
                </p:nvGrpSpPr>
                <p:grpSpPr>
                  <a:xfrm>
                    <a:off x="623086" y="3680015"/>
                    <a:ext cx="5707954" cy="2880002"/>
                    <a:chOff x="0" y="0"/>
                    <a:chExt cx="5717829" cy="3298744"/>
                  </a:xfrm>
                </p:grpSpPr>
                <p:grpSp>
                  <p:nvGrpSpPr>
                    <p:cNvPr id="35" name="그룹 34">
                      <a:extLst>
                        <a:ext uri="{FF2B5EF4-FFF2-40B4-BE49-F238E27FC236}">
                          <a16:creationId xmlns:a16="http://schemas.microsoft.com/office/drawing/2014/main" id="{F3E3F613-CE55-485E-A467-51057CA6518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0"/>
                      <a:ext cx="5717829" cy="3298744"/>
                      <a:chOff x="0" y="0"/>
                      <a:chExt cx="5695116" cy="3251851"/>
                    </a:xfrm>
                  </p:grpSpPr>
                  <p:grpSp>
                    <p:nvGrpSpPr>
                      <p:cNvPr id="37" name="그룹 36">
                        <a:extLst>
                          <a:ext uri="{FF2B5EF4-FFF2-40B4-BE49-F238E27FC236}">
                            <a16:creationId xmlns:a16="http://schemas.microsoft.com/office/drawing/2014/main" id="{632552AA-137C-453C-8426-D3391224810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0" y="0"/>
                        <a:ext cx="5695116" cy="3251851"/>
                        <a:chOff x="0" y="0"/>
                        <a:chExt cx="11105322" cy="4138820"/>
                      </a:xfrm>
                    </p:grpSpPr>
                    <p:graphicFrame>
                      <p:nvGraphicFramePr>
                        <p:cNvPr id="39" name="차트 38">
                          <a:extLst>
                            <a:ext uri="{FF2B5EF4-FFF2-40B4-BE49-F238E27FC236}">
                              <a16:creationId xmlns:a16="http://schemas.microsoft.com/office/drawing/2014/main" id="{8C195EC6-7BF5-4760-9F09-15BB5A7F015D}"/>
                            </a:ext>
                          </a:extLst>
                        </p:cNvPr>
                        <p:cNvGraphicFramePr>
                          <a:graphicFrameLocks/>
                        </p:cNvGraphicFramePr>
                        <p:nvPr/>
                      </p:nvGraphicFramePr>
                      <p:xfrm>
                        <a:off x="0" y="652478"/>
                        <a:ext cx="4681538" cy="2833864"/>
                      </p:xfrm>
                      <a:graphic>
                        <a:graphicData uri="http://schemas.openxmlformats.org/drawingml/2006/chart">
                          <c:chart xmlns:c="http://schemas.openxmlformats.org/drawingml/2006/chart" xmlns:r="http://schemas.openxmlformats.org/officeDocument/2006/relationships" r:id="rId4"/>
                        </a:graphicData>
                      </a:graphic>
                    </p:graphicFrame>
                    <p:graphicFrame>
                      <p:nvGraphicFramePr>
                        <p:cNvPr id="40" name="차트 39">
                          <a:extLst>
                            <a:ext uri="{FF2B5EF4-FFF2-40B4-BE49-F238E27FC236}">
                              <a16:creationId xmlns:a16="http://schemas.microsoft.com/office/drawing/2014/main" id="{412E9E28-3952-4C99-95F0-C25C6C833540}"/>
                            </a:ext>
                          </a:extLst>
                        </p:cNvPr>
                        <p:cNvGraphicFramePr>
                          <a:graphicFrameLocks/>
                        </p:cNvGraphicFramePr>
                        <p:nvPr/>
                      </p:nvGraphicFramePr>
                      <p:xfrm>
                        <a:off x="5273413" y="0"/>
                        <a:ext cx="5831909" cy="4138820"/>
                      </p:xfrm>
                      <a:graphic>
                        <a:graphicData uri="http://schemas.openxmlformats.org/drawingml/2006/chart">
                          <c:chart xmlns:c="http://schemas.openxmlformats.org/drawingml/2006/chart" xmlns:r="http://schemas.openxmlformats.org/officeDocument/2006/relationships" r:id="rId5"/>
                        </a:graphicData>
                      </a:graphic>
                    </p:graphicFrame>
                  </p:grpSp>
                  <p:cxnSp>
                    <p:nvCxnSpPr>
                      <p:cNvPr id="38" name="직선 연결선 37">
                        <a:extLst>
                          <a:ext uri="{FF2B5EF4-FFF2-40B4-BE49-F238E27FC236}">
                            <a16:creationId xmlns:a16="http://schemas.microsoft.com/office/drawing/2014/main" id="{1E73C66E-1640-4A0B-BA59-A60E7F9E9679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683824" y="2352308"/>
                        <a:ext cx="2051882" cy="438501"/>
                      </a:xfrm>
                      <a:prstGeom prst="line">
                        <a:avLst/>
                      </a:prstGeom>
                      <a:ln>
                        <a:solidFill>
                          <a:schemeClr val="accent3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36" name="직선 연결선 35">
                      <a:extLst>
                        <a:ext uri="{FF2B5EF4-FFF2-40B4-BE49-F238E27FC236}">
                          <a16:creationId xmlns:a16="http://schemas.microsoft.com/office/drawing/2014/main" id="{29472930-393E-47C9-88F4-1E8B0867A38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690540" y="448857"/>
                      <a:ext cx="2060065" cy="458178"/>
                    </a:xfrm>
                    <a:prstGeom prst="line">
                      <a:avLst/>
                    </a:prstGeom>
                    <a:ln>
                      <a:solidFill>
                        <a:schemeClr val="accent3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23" name="그룹 22">
                  <a:extLst>
                    <a:ext uri="{FF2B5EF4-FFF2-40B4-BE49-F238E27FC236}">
                      <a16:creationId xmlns:a16="http://schemas.microsoft.com/office/drawing/2014/main" id="{7A071214-BC29-4F5E-B752-D9683CBDFCF5}"/>
                    </a:ext>
                  </a:extLst>
                </p:cNvPr>
                <p:cNvGrpSpPr/>
                <p:nvPr/>
              </p:nvGrpSpPr>
              <p:grpSpPr>
                <a:xfrm>
                  <a:off x="515254" y="6538005"/>
                  <a:ext cx="5816199" cy="2938970"/>
                  <a:chOff x="515254" y="6538005"/>
                  <a:chExt cx="5816199" cy="2938970"/>
                </a:xfrm>
              </p:grpSpPr>
              <p:sp>
                <p:nvSpPr>
                  <p:cNvPr id="48" name="TextBox 47">
                    <a:extLst>
                      <a:ext uri="{FF2B5EF4-FFF2-40B4-BE49-F238E27FC236}">
                        <a16:creationId xmlns:a16="http://schemas.microsoft.com/office/drawing/2014/main" id="{1CCE139B-33F4-42FE-852F-5255F617D6FF}"/>
                      </a:ext>
                    </a:extLst>
                  </p:cNvPr>
                  <p:cNvSpPr txBox="1"/>
                  <p:nvPr/>
                </p:nvSpPr>
                <p:spPr>
                  <a:xfrm>
                    <a:off x="515254" y="6538005"/>
                    <a:ext cx="171874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Female cancer deaths, 2020</a:t>
                    </a:r>
                    <a:endParaRPr lang="ko-KR" alt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grpSp>
                <p:nvGrpSpPr>
                  <p:cNvPr id="41" name="그룹 40">
                    <a:extLst>
                      <a:ext uri="{FF2B5EF4-FFF2-40B4-BE49-F238E27FC236}">
                        <a16:creationId xmlns:a16="http://schemas.microsoft.com/office/drawing/2014/main" id="{55849A5F-F0DC-4BD8-930B-362DD41C2B49}"/>
                      </a:ext>
                    </a:extLst>
                  </p:cNvPr>
                  <p:cNvGrpSpPr/>
                  <p:nvPr/>
                </p:nvGrpSpPr>
                <p:grpSpPr>
                  <a:xfrm>
                    <a:off x="623086" y="6596976"/>
                    <a:ext cx="5708367" cy="2879999"/>
                    <a:chOff x="0" y="0"/>
                    <a:chExt cx="5708367" cy="3214577"/>
                  </a:xfrm>
                </p:grpSpPr>
                <p:grpSp>
                  <p:nvGrpSpPr>
                    <p:cNvPr id="42" name="그룹 41">
                      <a:extLst>
                        <a:ext uri="{FF2B5EF4-FFF2-40B4-BE49-F238E27FC236}">
                          <a16:creationId xmlns:a16="http://schemas.microsoft.com/office/drawing/2014/main" id="{B273E68F-1C2F-4543-8335-236A581BEC9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0"/>
                      <a:ext cx="5708367" cy="3214577"/>
                      <a:chOff x="0" y="0"/>
                      <a:chExt cx="11105322" cy="4138820"/>
                    </a:xfrm>
                  </p:grpSpPr>
                  <p:graphicFrame>
                    <p:nvGraphicFramePr>
                      <p:cNvPr id="45" name="차트 44">
                        <a:extLst>
                          <a:ext uri="{FF2B5EF4-FFF2-40B4-BE49-F238E27FC236}">
                            <a16:creationId xmlns:a16="http://schemas.microsoft.com/office/drawing/2014/main" id="{4AE202A0-D064-4CE5-B05E-4D86FE919BF2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0" y="652478"/>
                      <a:ext cx="4681538" cy="2833864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6"/>
                      </a:graphicData>
                    </a:graphic>
                  </p:graphicFrame>
                  <p:graphicFrame>
                    <p:nvGraphicFramePr>
                      <p:cNvPr id="54" name="차트 53">
                        <a:extLst>
                          <a:ext uri="{FF2B5EF4-FFF2-40B4-BE49-F238E27FC236}">
                            <a16:creationId xmlns:a16="http://schemas.microsoft.com/office/drawing/2014/main" id="{2E377610-BDA5-4932-A93B-6B739AFA7D2F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5273414" y="0"/>
                      <a:ext cx="5831908" cy="4138820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7"/>
                      </a:graphicData>
                    </a:graphic>
                  </p:graphicFrame>
                </p:grpSp>
                <p:cxnSp>
                  <p:nvCxnSpPr>
                    <p:cNvPr id="43" name="직선 연결선 42">
                      <a:extLst>
                        <a:ext uri="{FF2B5EF4-FFF2-40B4-BE49-F238E27FC236}">
                          <a16:creationId xmlns:a16="http://schemas.microsoft.com/office/drawing/2014/main" id="{6915ADB8-81CB-41C3-B940-73A7C677D4F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2033473" y="424243"/>
                      <a:ext cx="1815429" cy="1018335"/>
                    </a:xfrm>
                    <a:prstGeom prst="line">
                      <a:avLst/>
                    </a:prstGeom>
                    <a:ln>
                      <a:solidFill>
                        <a:schemeClr val="accent3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4" name="직선 연결선 43">
                      <a:extLst>
                        <a:ext uri="{FF2B5EF4-FFF2-40B4-BE49-F238E27FC236}">
                          <a16:creationId xmlns:a16="http://schemas.microsoft.com/office/drawing/2014/main" id="{0033633A-1971-4D49-85AC-7748298802C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33473" y="1755348"/>
                      <a:ext cx="1815820" cy="1160829"/>
                    </a:xfrm>
                    <a:prstGeom prst="line">
                      <a:avLst/>
                    </a:prstGeom>
                    <a:ln>
                      <a:solidFill>
                        <a:schemeClr val="accent3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  <p:cxnSp>
            <p:nvCxnSpPr>
              <p:cNvPr id="28" name="직선 연결선 27">
                <a:extLst>
                  <a:ext uri="{FF2B5EF4-FFF2-40B4-BE49-F238E27FC236}">
                    <a16:creationId xmlns:a16="http://schemas.microsoft.com/office/drawing/2014/main" id="{DA7283C5-5DB5-40DC-953E-24E6E229AEB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482289" y="1053138"/>
                <a:ext cx="1936595" cy="610644"/>
              </a:xfrm>
              <a:prstGeom prst="line">
                <a:avLst/>
              </a:prstGeom>
              <a:ln>
                <a:solidFill>
                  <a:schemeClr val="accent3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477304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</TotalTime>
  <Words>156</Words>
  <Application>Microsoft Office PowerPoint</Application>
  <PresentationFormat>A4 용지(210x297mm)</PresentationFormat>
  <Paragraphs>4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oseul Sung</dc:creator>
  <cp:lastModifiedBy>이제인</cp:lastModifiedBy>
  <cp:revision>14</cp:revision>
  <dcterms:created xsi:type="dcterms:W3CDTF">2024-07-22T05:46:04Z</dcterms:created>
  <dcterms:modified xsi:type="dcterms:W3CDTF">2025-09-26T00:05:06Z</dcterms:modified>
</cp:coreProperties>
</file>